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jpeg" ContentType="image/jpeg"/>
  <Override PartName="/ppt/media/image12.jpeg" ContentType="image/jpeg"/>
  <Override PartName="/ppt/media/image10.jpeg" ContentType="image/jpeg"/>
  <Override PartName="/ppt/media/image5.png" ContentType="image/png"/>
  <Override PartName="/ppt/media/image18.png" ContentType="image/png"/>
  <Override PartName="/ppt/media/image15.jpeg" ContentType="image/jpeg"/>
  <Override PartName="/ppt/media/image17.jpeg" ContentType="image/jpeg"/>
  <Override PartName="/ppt/media/image16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6.jpeg" ContentType="image/jpeg"/>
  <Override PartName="/ppt/media/image9.jpeg" ContentType="image/jpeg"/>
  <Override PartName="/ppt/media/image11.jpeg" ContentType="image/jpeg"/>
  <Override PartName="/ppt/media/image8.png" ContentType="image/png"/>
  <Override PartName="/ppt/media/image14.jpeg" ContentType="image/jpeg"/>
  <Override PartName="/ppt/media/image1.jpeg" ContentType="image/jpe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61E132-AE31-4918-8838-37E7A65C01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55264-3ADE-4344-9346-77BC6433A5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D82DF5-BA28-4AAD-99B2-7698EFE95B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9663F4-F2A4-4FCA-A4D6-AD14502A43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CCA9E-4FB8-487E-B19E-34855F16B1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D12CE-A02D-4D70-9E15-245066415A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9691F-97CB-421E-857B-7BC468043D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31A0E9-589F-47B5-AB26-58CB02D9FC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C99DB-0EDF-43EF-BF39-FF41B85F65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9FE91-1210-4BCA-9F7D-F4D282688B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D3B490-AFE8-4900-97C2-EEC09C392D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F7790-69BB-4AB1-BDBF-D6B85B4E72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9B8EFF-8918-42D9-9709-F36DBD25988C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11.jpeg"/><Relationship Id="rId3" Type="http://schemas.openxmlformats.org/officeDocument/2006/relationships/image" Target="../media/image12.jpeg"/><Relationship Id="rId4" Type="http://schemas.openxmlformats.org/officeDocument/2006/relationships/image" Target="../media/image13.jpeg"/><Relationship Id="rId5" Type="http://schemas.openxmlformats.org/officeDocument/2006/relationships/image" Target="../media/image14.jpeg"/><Relationship Id="rId6" Type="http://schemas.openxmlformats.org/officeDocument/2006/relationships/image" Target="../media/image15.jpeg"/><Relationship Id="rId7" Type="http://schemas.openxmlformats.org/officeDocument/2006/relationships/image" Target="../media/image16.jpeg"/><Relationship Id="rId8" Type="http://schemas.openxmlformats.org/officeDocument/2006/relationships/image" Target="../media/image17.jpeg"/><Relationship Id="rId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그룹 34"/>
          <p:cNvGrpSpPr/>
          <p:nvPr/>
        </p:nvGrpSpPr>
        <p:grpSpPr>
          <a:xfrm>
            <a:off x="1428840" y="719280"/>
            <a:ext cx="3143160" cy="4138560"/>
            <a:chOff x="1428840" y="719280"/>
            <a:chExt cx="3143160" cy="4138560"/>
          </a:xfrm>
        </p:grpSpPr>
        <p:pic>
          <p:nvPicPr>
            <p:cNvPr id="42" name="Picture 13" descr="AP2 e final ok 2"/>
            <p:cNvPicPr/>
            <p:nvPr/>
          </p:nvPicPr>
          <p:blipFill>
            <a:blip r:embed="rId1"/>
            <a:srcRect l="0" t="0" r="2406" b="11091"/>
            <a:stretch/>
          </p:blipFill>
          <p:spPr>
            <a:xfrm>
              <a:off x="1487520" y="3857760"/>
              <a:ext cx="3022560" cy="35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15" descr="control B3"/>
            <p:cNvPicPr/>
            <p:nvPr/>
          </p:nvPicPr>
          <p:blipFill>
            <a:blip r:embed="rId2"/>
            <a:srcRect l="3529" t="0" r="4411" b="20750"/>
            <a:stretch/>
          </p:blipFill>
          <p:spPr>
            <a:xfrm>
              <a:off x="1485720" y="4500720"/>
              <a:ext cx="3024360" cy="35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7" descr="AP2 b final ok 2"/>
            <p:cNvPicPr/>
            <p:nvPr/>
          </p:nvPicPr>
          <p:blipFill>
            <a:blip r:embed="rId3"/>
            <a:srcRect l="1444" t="0" r="0" b="16174"/>
            <a:stretch/>
          </p:blipFill>
          <p:spPr>
            <a:xfrm>
              <a:off x="1485720" y="2571840"/>
              <a:ext cx="3027240" cy="42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12" descr="AP2 d final ok 2"/>
            <p:cNvPicPr/>
            <p:nvPr/>
          </p:nvPicPr>
          <p:blipFill>
            <a:blip r:embed="rId4"/>
            <a:srcRect l="0" t="0" r="2416" b="0"/>
            <a:stretch/>
          </p:blipFill>
          <p:spPr>
            <a:xfrm>
              <a:off x="1485720" y="3286080"/>
              <a:ext cx="3024360" cy="37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6" descr="AP2-a ok"/>
            <p:cNvPicPr/>
            <p:nvPr/>
          </p:nvPicPr>
          <p:blipFill>
            <a:blip r:embed="rId5"/>
            <a:srcRect l="0" t="0" r="0" b="14986"/>
            <a:stretch/>
          </p:blipFill>
          <p:spPr>
            <a:xfrm>
              <a:off x="1500120" y="1933560"/>
              <a:ext cx="3000600" cy="423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직선 연결선 11"/>
            <p:cNvSpPr/>
            <p:nvPr/>
          </p:nvSpPr>
          <p:spPr>
            <a:xfrm>
              <a:off x="1571400" y="1147680"/>
              <a:ext cx="27147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8" name="TextBox 12"/>
            <p:cNvSpPr/>
            <p:nvPr/>
          </p:nvSpPr>
          <p:spPr>
            <a:xfrm>
              <a:off x="1428840" y="1290600"/>
              <a:ext cx="13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" name="TextBox 13"/>
            <p:cNvSpPr/>
            <p:nvPr/>
          </p:nvSpPr>
          <p:spPr>
            <a:xfrm>
              <a:off x="2357280" y="1219320"/>
              <a:ext cx="2214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 </a:t>
              </a:r>
              <a:r>
                <a:rPr b="0" i="1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iR172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 OE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" name="직선 연결선 15"/>
            <p:cNvSpPr/>
            <p:nvPr/>
          </p:nvSpPr>
          <p:spPr>
            <a:xfrm>
              <a:off x="1500120" y="1576440"/>
              <a:ext cx="27147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1" name="TextBox 16"/>
            <p:cNvSpPr/>
            <p:nvPr/>
          </p:nvSpPr>
          <p:spPr>
            <a:xfrm>
              <a:off x="2000160" y="719280"/>
              <a:ext cx="1928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3 stage</a:t>
              </a: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" name="TextBox 17"/>
            <p:cNvSpPr/>
            <p:nvPr/>
          </p:nvSpPr>
          <p:spPr>
            <a:xfrm>
              <a:off x="2786040" y="1576440"/>
              <a:ext cx="64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#13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3" name="TextBox 18"/>
            <p:cNvSpPr/>
            <p:nvPr/>
          </p:nvSpPr>
          <p:spPr>
            <a:xfrm>
              <a:off x="3643560" y="1576440"/>
              <a:ext cx="64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#16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54" name="그룹 33"/>
          <p:cNvGrpSpPr/>
          <p:nvPr/>
        </p:nvGrpSpPr>
        <p:grpSpPr>
          <a:xfrm>
            <a:off x="6143760" y="830160"/>
            <a:ext cx="2676240" cy="1879560"/>
            <a:chOff x="6143760" y="830160"/>
            <a:chExt cx="2676240" cy="1879560"/>
          </a:xfrm>
        </p:grpSpPr>
        <p:pic>
          <p:nvPicPr>
            <p:cNvPr id="55" name="Picture 9" descr="AP2 FL final ok2"/>
            <p:cNvPicPr/>
            <p:nvPr/>
          </p:nvPicPr>
          <p:blipFill>
            <a:blip r:embed="rId6"/>
            <a:srcRect l="0" t="14686" r="0" b="16015"/>
            <a:stretch/>
          </p:blipFill>
          <p:spPr>
            <a:xfrm>
              <a:off x="6357960" y="1857600"/>
              <a:ext cx="1961640" cy="337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11" descr="AP2-FL con OK"/>
            <p:cNvPicPr/>
            <p:nvPr/>
          </p:nvPicPr>
          <p:blipFill>
            <a:blip r:embed="rId7"/>
            <a:srcRect l="3267" t="0" r="7342" b="0"/>
            <a:stretch/>
          </p:blipFill>
          <p:spPr>
            <a:xfrm>
              <a:off x="6357960" y="2308320"/>
              <a:ext cx="1950480" cy="401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직선 연결선 23"/>
            <p:cNvSpPr/>
            <p:nvPr/>
          </p:nvSpPr>
          <p:spPr>
            <a:xfrm>
              <a:off x="6143760" y="1258560"/>
              <a:ext cx="24998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8" name="TextBox 24"/>
            <p:cNvSpPr/>
            <p:nvPr/>
          </p:nvSpPr>
          <p:spPr>
            <a:xfrm>
              <a:off x="6357960" y="1352880"/>
              <a:ext cx="1356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9" name="TextBox 25"/>
            <p:cNvSpPr/>
            <p:nvPr/>
          </p:nvSpPr>
          <p:spPr>
            <a:xfrm>
              <a:off x="7000920" y="1329840"/>
              <a:ext cx="181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iR172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 OE  #13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0" name="직선 연결선 26"/>
            <p:cNvSpPr/>
            <p:nvPr/>
          </p:nvSpPr>
          <p:spPr>
            <a:xfrm>
              <a:off x="6357960" y="1686240"/>
              <a:ext cx="19504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1" name="TextBox 27"/>
            <p:cNvSpPr/>
            <p:nvPr/>
          </p:nvSpPr>
          <p:spPr>
            <a:xfrm>
              <a:off x="6540480" y="830160"/>
              <a:ext cx="1928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Flower</a:t>
              </a: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62" name="TextBox 35"/>
          <p:cNvSpPr/>
          <p:nvPr/>
        </p:nvSpPr>
        <p:spPr>
          <a:xfrm>
            <a:off x="500040" y="19479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SlAP2a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TextBox 36"/>
          <p:cNvSpPr/>
          <p:nvPr/>
        </p:nvSpPr>
        <p:spPr>
          <a:xfrm>
            <a:off x="500040" y="257184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SlAP2c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4" name="TextBox 37"/>
          <p:cNvSpPr/>
          <p:nvPr/>
        </p:nvSpPr>
        <p:spPr>
          <a:xfrm>
            <a:off x="428760" y="328464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Target 4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5" name="TextBox 38"/>
          <p:cNvSpPr/>
          <p:nvPr/>
        </p:nvSpPr>
        <p:spPr>
          <a:xfrm>
            <a:off x="428760" y="38577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Target 5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TextBox 39"/>
          <p:cNvSpPr/>
          <p:nvPr/>
        </p:nvSpPr>
        <p:spPr>
          <a:xfrm>
            <a:off x="357120" y="4429080"/>
            <a:ext cx="114300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SlEF1-</a:t>
            </a:r>
            <a:r>
              <a:rPr b="0" i="1" lang="el-GR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α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(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control)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7" name="TextBox 40"/>
          <p:cNvSpPr/>
          <p:nvPr/>
        </p:nvSpPr>
        <p:spPr>
          <a:xfrm>
            <a:off x="5364000" y="184932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SlAP2b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TextBox 41"/>
          <p:cNvSpPr/>
          <p:nvPr/>
        </p:nvSpPr>
        <p:spPr>
          <a:xfrm>
            <a:off x="179280" y="5357880"/>
            <a:ext cx="8785440" cy="105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 S1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ACE-PCR analysis of miR172 cleaved products. Analysis was performed on wild-type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17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E lines for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ripening stage fruit (B3) and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flowers. A fragment of the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1-α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was amplified in the same PCR reaction as an internal control.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TextBox 43"/>
          <p:cNvSpPr/>
          <p:nvPr/>
        </p:nvSpPr>
        <p:spPr>
          <a:xfrm>
            <a:off x="5286240" y="2278080"/>
            <a:ext cx="114300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SlEF1-</a:t>
            </a:r>
            <a:r>
              <a:rPr b="0" i="1" lang="el-GR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α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(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control)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0" name="TextBox 30"/>
          <p:cNvSpPr/>
          <p:nvPr/>
        </p:nvSpPr>
        <p:spPr>
          <a:xfrm>
            <a:off x="500040" y="1063800"/>
            <a:ext cx="4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굴림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TextBox 31"/>
          <p:cNvSpPr/>
          <p:nvPr/>
        </p:nvSpPr>
        <p:spPr>
          <a:xfrm>
            <a:off x="5286240" y="1165320"/>
            <a:ext cx="4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굴림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직사각형 36"/>
          <p:cNvSpPr/>
          <p:nvPr/>
        </p:nvSpPr>
        <p:spPr>
          <a:xfrm>
            <a:off x="179280" y="4214880"/>
            <a:ext cx="8678880" cy="105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 S2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xpression level of the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AP2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in wild-type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172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E lines. WT and miR172 OE lines #16 and #26 tissues (L, leaf; B, breaker; B3, 3 days after breaker) were analyzed. The same filter was stripped and rehybridized to tomato a18S rRNA probe as a loading control.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73" name="그룹 36"/>
          <p:cNvGrpSpPr/>
          <p:nvPr/>
        </p:nvGrpSpPr>
        <p:grpSpPr>
          <a:xfrm>
            <a:off x="357120" y="1441440"/>
            <a:ext cx="7596360" cy="2344680"/>
            <a:chOff x="357120" y="1441440"/>
            <a:chExt cx="7596360" cy="2344680"/>
          </a:xfrm>
        </p:grpSpPr>
        <p:grpSp>
          <p:nvGrpSpPr>
            <p:cNvPr id="74" name="그룹 51"/>
            <p:cNvGrpSpPr/>
            <p:nvPr/>
          </p:nvGrpSpPr>
          <p:grpSpPr>
            <a:xfrm>
              <a:off x="1431720" y="1441440"/>
              <a:ext cx="6496200" cy="1644840"/>
              <a:chOff x="1431720" y="1441440"/>
              <a:chExt cx="6496200" cy="1644840"/>
            </a:xfrm>
          </p:grpSpPr>
          <p:pic>
            <p:nvPicPr>
              <p:cNvPr id="75" name="그림 25" descr="AP2 B B3 m172.jpg"/>
              <p:cNvPicPr/>
              <p:nvPr/>
            </p:nvPicPr>
            <p:blipFill>
              <a:blip r:embed="rId1"/>
              <a:stretch/>
            </p:blipFill>
            <p:spPr>
              <a:xfrm>
                <a:off x="1431720" y="2513160"/>
                <a:ext cx="6496200" cy="573120"/>
              </a:xfrm>
              <a:prstGeom prst="rect">
                <a:avLst/>
              </a:prstGeom>
              <a:ln w="19080">
                <a:solidFill>
                  <a:srgbClr val="000000"/>
                </a:solidFill>
                <a:miter/>
              </a:ln>
            </p:spPr>
          </p:pic>
          <p:grpSp>
            <p:nvGrpSpPr>
              <p:cNvPr id="76" name="그룹 32"/>
              <p:cNvGrpSpPr/>
              <p:nvPr/>
            </p:nvGrpSpPr>
            <p:grpSpPr>
              <a:xfrm>
                <a:off x="3624120" y="2225880"/>
                <a:ext cx="2030760" cy="277920"/>
                <a:chOff x="3624120" y="2225880"/>
                <a:chExt cx="2030760" cy="277920"/>
              </a:xfrm>
            </p:grpSpPr>
            <p:sp>
              <p:nvSpPr>
                <p:cNvPr id="77" name="직선 연결선 27"/>
                <p:cNvSpPr/>
                <p:nvPr/>
              </p:nvSpPr>
              <p:spPr>
                <a:xfrm>
                  <a:off x="3727080" y="2225880"/>
                  <a:ext cx="178596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78" name="TextBox 31"/>
                <p:cNvSpPr/>
                <p:nvPr/>
              </p:nvSpPr>
              <p:spPr>
                <a:xfrm>
                  <a:off x="3624120" y="2227320"/>
                  <a:ext cx="2030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굴림"/>
                    </a:rPr>
                    <a:t>WT    M #13  M #16   M #26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굴림"/>
                      <a:ea typeface="굴림"/>
                    </a:rPr>
                    <a:t> </a:t>
                  </a:r>
                  <a:endParaRPr b="0" lang="en-US" sz="12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</p:grpSp>
          <p:sp>
            <p:nvSpPr>
              <p:cNvPr id="79" name="직선 연결선 33"/>
              <p:cNvSpPr/>
              <p:nvPr/>
            </p:nvSpPr>
            <p:spPr>
              <a:xfrm>
                <a:off x="5665680" y="2235240"/>
                <a:ext cx="20430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grpSp>
            <p:nvGrpSpPr>
              <p:cNvPr id="80" name="그룹 39"/>
              <p:cNvGrpSpPr/>
              <p:nvPr/>
            </p:nvGrpSpPr>
            <p:grpSpPr>
              <a:xfrm>
                <a:off x="1521000" y="2235240"/>
                <a:ext cx="2156040" cy="277200"/>
                <a:chOff x="1521000" y="2235240"/>
                <a:chExt cx="2156040" cy="277200"/>
              </a:xfrm>
            </p:grpSpPr>
            <p:sp>
              <p:nvSpPr>
                <p:cNvPr id="81" name="직선 연결선 40"/>
                <p:cNvSpPr/>
                <p:nvPr/>
              </p:nvSpPr>
              <p:spPr>
                <a:xfrm>
                  <a:off x="1726560" y="2235240"/>
                  <a:ext cx="178596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82" name="TextBox 41"/>
                <p:cNvSpPr/>
                <p:nvPr/>
              </p:nvSpPr>
              <p:spPr>
                <a:xfrm>
                  <a:off x="1521000" y="2235960"/>
                  <a:ext cx="2156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굴림"/>
                    </a:rPr>
                    <a:t>WT     M #13   M #16   M #26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굴림"/>
                      <a:ea typeface="굴림"/>
                    </a:rPr>
                    <a:t> </a:t>
                  </a:r>
                  <a:endParaRPr b="0" lang="en-US" sz="12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</p:grpSp>
          <p:sp>
            <p:nvSpPr>
              <p:cNvPr id="83" name="TextBox 42"/>
              <p:cNvSpPr/>
              <p:nvPr/>
            </p:nvSpPr>
            <p:spPr>
              <a:xfrm>
                <a:off x="2369880" y="1857240"/>
                <a:ext cx="785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Leaf</a:t>
                </a:r>
                <a:endParaRPr b="0" lang="en-US" sz="1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4" name="TextBox 43"/>
              <p:cNvSpPr/>
              <p:nvPr/>
            </p:nvSpPr>
            <p:spPr>
              <a:xfrm>
                <a:off x="4513680" y="1895040"/>
                <a:ext cx="428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B</a:t>
                </a:r>
                <a:endParaRPr b="0" lang="en-US" sz="1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5" name="TextBox 44"/>
              <p:cNvSpPr/>
              <p:nvPr/>
            </p:nvSpPr>
            <p:spPr>
              <a:xfrm>
                <a:off x="6299640" y="1895040"/>
                <a:ext cx="6429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B3</a:t>
                </a:r>
                <a:endParaRPr b="0" lang="en-US" sz="1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6" name="직선 연결선 46"/>
              <p:cNvSpPr/>
              <p:nvPr/>
            </p:nvSpPr>
            <p:spPr>
              <a:xfrm>
                <a:off x="1774440" y="1870200"/>
                <a:ext cx="590436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7" name="TextBox 49"/>
              <p:cNvSpPr/>
              <p:nvPr/>
            </p:nvSpPr>
            <p:spPr>
              <a:xfrm>
                <a:off x="2941200" y="1441440"/>
                <a:ext cx="4000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Developmental stages</a:t>
                </a: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88" name="TextBox 52"/>
            <p:cNvSpPr/>
            <p:nvPr/>
          </p:nvSpPr>
          <p:spPr>
            <a:xfrm>
              <a:off x="357120" y="2571840"/>
              <a:ext cx="1143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SlAP2a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89" name="Picture 37" descr="18s AP2 OK"/>
            <p:cNvPicPr/>
            <p:nvPr/>
          </p:nvPicPr>
          <p:blipFill>
            <a:blip r:embed="rId2"/>
            <a:srcRect l="2520" t="0" r="4853" b="0"/>
            <a:stretch/>
          </p:blipFill>
          <p:spPr>
            <a:xfrm>
              <a:off x="1411200" y="3186000"/>
              <a:ext cx="6542280" cy="60012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90" name="TextBox 52"/>
            <p:cNvSpPr/>
            <p:nvPr/>
          </p:nvSpPr>
          <p:spPr>
            <a:xfrm>
              <a:off x="357120" y="3186000"/>
              <a:ext cx="1143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8S RNA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91" name="TextBox 31"/>
          <p:cNvSpPr/>
          <p:nvPr/>
        </p:nvSpPr>
        <p:spPr>
          <a:xfrm>
            <a:off x="5568840" y="2227320"/>
            <a:ext cx="214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WT    M #13  M #16   M #26</a:t>
            </a:r>
            <a:r>
              <a:rPr b="0" lang="en-US" sz="1200" spc="-1" strike="noStrike">
                <a:solidFill>
                  <a:srgbClr val="000000"/>
                </a:solidFill>
                <a:latin typeface="굴림"/>
                <a:ea typeface="굴림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직사각형 4"/>
          <p:cNvSpPr/>
          <p:nvPr/>
        </p:nvSpPr>
        <p:spPr>
          <a:xfrm>
            <a:off x="108000" y="5214960"/>
            <a:ext cx="8856720" cy="169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 S3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172 transcript abundance in wild-type (WT) and ripening mutants (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in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r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r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r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  Tomato tissues (L, leaf; F, flower; D10, 10 days after 1 cm fruit; D20, 20 days after 1 cm fruit; D30, 30 days after 1 cm fruit; D35, 35 days after 1 cm fruit), were harvested, extracted for total RNA and 50 μg was loaded for RNA gel-blot analysis using a 5′-end-labeled DNA oligonucleotide probe complementary to miR172. 5S rRNA was used as a loading control.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93" name="그룹 69"/>
          <p:cNvGrpSpPr/>
          <p:nvPr/>
        </p:nvGrpSpPr>
        <p:grpSpPr>
          <a:xfrm>
            <a:off x="2179800" y="0"/>
            <a:ext cx="4749480" cy="1357200"/>
            <a:chOff x="2179800" y="0"/>
            <a:chExt cx="4749480" cy="1357200"/>
          </a:xfrm>
        </p:grpSpPr>
        <p:grpSp>
          <p:nvGrpSpPr>
            <p:cNvPr id="94" name="그룹 35"/>
            <p:cNvGrpSpPr/>
            <p:nvPr/>
          </p:nvGrpSpPr>
          <p:grpSpPr>
            <a:xfrm>
              <a:off x="2179800" y="696960"/>
              <a:ext cx="4749480" cy="660240"/>
              <a:chOff x="2179800" y="696960"/>
              <a:chExt cx="4749480" cy="660240"/>
            </a:xfrm>
          </p:grpSpPr>
          <p:sp>
            <p:nvSpPr>
              <p:cNvPr id="95" name="Text Box 18"/>
              <p:cNvSpPr/>
              <p:nvPr/>
            </p:nvSpPr>
            <p:spPr>
              <a:xfrm>
                <a:off x="2700360" y="696960"/>
                <a:ext cx="1871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6" name="직선 연결선 10"/>
              <p:cNvSpPr/>
              <p:nvPr/>
            </p:nvSpPr>
            <p:spPr>
              <a:xfrm>
                <a:off x="4681440" y="928800"/>
                <a:ext cx="19476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7" name="Text Box 20"/>
              <p:cNvSpPr/>
              <p:nvPr/>
            </p:nvSpPr>
            <p:spPr>
              <a:xfrm>
                <a:off x="5057640" y="696960"/>
                <a:ext cx="1871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굴림"/>
                    <a:ea typeface="굴림"/>
                  </a:rPr>
                  <a:t>rin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pic>
            <p:nvPicPr>
              <p:cNvPr id="98" name="그림 19" descr="Rin m172 Ok.jpg"/>
              <p:cNvPicPr/>
              <p:nvPr/>
            </p:nvPicPr>
            <p:blipFill>
              <a:blip r:embed="rId1"/>
              <a:srcRect l="15584" t="25607" r="9977" b="12399"/>
              <a:stretch/>
            </p:blipFill>
            <p:spPr>
              <a:xfrm>
                <a:off x="2179800" y="1000080"/>
                <a:ext cx="4679640" cy="35712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sp>
            <p:nvSpPr>
              <p:cNvPr id="99" name="직선 연결선 24"/>
              <p:cNvSpPr/>
              <p:nvPr/>
            </p:nvSpPr>
            <p:spPr>
              <a:xfrm>
                <a:off x="2557440" y="928800"/>
                <a:ext cx="2000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0" name="직선 연결선 28"/>
              <p:cNvSpPr/>
              <p:nvPr/>
            </p:nvSpPr>
            <p:spPr>
              <a:xfrm>
                <a:off x="2557440" y="696960"/>
                <a:ext cx="40719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101" name="TextBox 29"/>
            <p:cNvSpPr/>
            <p:nvPr/>
          </p:nvSpPr>
          <p:spPr>
            <a:xfrm>
              <a:off x="2557440" y="437400"/>
              <a:ext cx="2071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L        F      D10     D20    D30   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2" name="TextBox 31"/>
            <p:cNvSpPr/>
            <p:nvPr/>
          </p:nvSpPr>
          <p:spPr>
            <a:xfrm>
              <a:off x="4700520" y="419760"/>
              <a:ext cx="2071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L        F      D10     D20    D30   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3" name="직선 연결선 33"/>
            <p:cNvSpPr/>
            <p:nvPr/>
          </p:nvSpPr>
          <p:spPr>
            <a:xfrm>
              <a:off x="2628720" y="357120"/>
              <a:ext cx="40003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4" name="TextBox 34"/>
            <p:cNvSpPr/>
            <p:nvPr/>
          </p:nvSpPr>
          <p:spPr>
            <a:xfrm>
              <a:off x="2700360" y="0"/>
              <a:ext cx="3571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Developmental stage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105" name="그룹 49"/>
          <p:cNvGrpSpPr/>
          <p:nvPr/>
        </p:nvGrpSpPr>
        <p:grpSpPr>
          <a:xfrm>
            <a:off x="2550960" y="2681280"/>
            <a:ext cx="4372200" cy="276480"/>
            <a:chOff x="2550960" y="2681280"/>
            <a:chExt cx="4372200" cy="276480"/>
          </a:xfrm>
        </p:grpSpPr>
        <p:sp>
          <p:nvSpPr>
            <p:cNvPr id="106" name="Text Box 18"/>
            <p:cNvSpPr/>
            <p:nvPr/>
          </p:nvSpPr>
          <p:spPr>
            <a:xfrm>
              <a:off x="2693520" y="2681280"/>
              <a:ext cx="187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7" name="직선 연결선 10"/>
            <p:cNvSpPr/>
            <p:nvPr/>
          </p:nvSpPr>
          <p:spPr>
            <a:xfrm>
              <a:off x="4675320" y="2912400"/>
              <a:ext cx="19479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8" name="Text Box 20"/>
            <p:cNvSpPr/>
            <p:nvPr/>
          </p:nvSpPr>
          <p:spPr>
            <a:xfrm>
              <a:off x="5051520" y="2681280"/>
              <a:ext cx="187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굴림"/>
                  <a:ea typeface="굴림"/>
                </a:rPr>
                <a:t>Nr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9" name="직선 연결선 58"/>
            <p:cNvSpPr/>
            <p:nvPr/>
          </p:nvSpPr>
          <p:spPr>
            <a:xfrm>
              <a:off x="2550960" y="2913120"/>
              <a:ext cx="2000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pic>
        <p:nvPicPr>
          <p:cNvPr id="110" name="그림 70" descr="Rin m172con ok.jpg"/>
          <p:cNvPicPr/>
          <p:nvPr/>
        </p:nvPicPr>
        <p:blipFill>
          <a:blip r:embed="rId2"/>
          <a:srcRect l="7521" t="4716" r="6248" b="19057"/>
          <a:stretch/>
        </p:blipFill>
        <p:spPr>
          <a:xfrm>
            <a:off x="2179800" y="1428840"/>
            <a:ext cx="4679640" cy="2858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grpSp>
        <p:nvGrpSpPr>
          <p:cNvPr id="111" name="그룹 72"/>
          <p:cNvGrpSpPr/>
          <p:nvPr/>
        </p:nvGrpSpPr>
        <p:grpSpPr>
          <a:xfrm>
            <a:off x="2179800" y="1719360"/>
            <a:ext cx="4743360" cy="642960"/>
            <a:chOff x="2179800" y="1719360"/>
            <a:chExt cx="4743360" cy="642960"/>
          </a:xfrm>
        </p:grpSpPr>
        <p:grpSp>
          <p:nvGrpSpPr>
            <p:cNvPr id="112" name="그룹 38"/>
            <p:cNvGrpSpPr/>
            <p:nvPr/>
          </p:nvGrpSpPr>
          <p:grpSpPr>
            <a:xfrm>
              <a:off x="2551320" y="1719360"/>
              <a:ext cx="4371840" cy="276480"/>
              <a:chOff x="2551320" y="1719360"/>
              <a:chExt cx="4371840" cy="276480"/>
            </a:xfrm>
          </p:grpSpPr>
          <p:sp>
            <p:nvSpPr>
              <p:cNvPr id="113" name="Text Box 18"/>
              <p:cNvSpPr/>
              <p:nvPr/>
            </p:nvSpPr>
            <p:spPr>
              <a:xfrm>
                <a:off x="2693880" y="1719360"/>
                <a:ext cx="1871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4" name="직선 연결선 10"/>
              <p:cNvSpPr/>
              <p:nvPr/>
            </p:nvSpPr>
            <p:spPr>
              <a:xfrm>
                <a:off x="4675320" y="1951200"/>
                <a:ext cx="19476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5" name="Text Box 20"/>
              <p:cNvSpPr/>
              <p:nvPr/>
            </p:nvSpPr>
            <p:spPr>
              <a:xfrm>
                <a:off x="5051520" y="1719360"/>
                <a:ext cx="1871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굴림"/>
                    <a:ea typeface="굴림"/>
                  </a:rPr>
                  <a:t>nor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6" name="직선 연결선 47"/>
              <p:cNvSpPr/>
              <p:nvPr/>
            </p:nvSpPr>
            <p:spPr>
              <a:xfrm>
                <a:off x="2551320" y="1951200"/>
                <a:ext cx="2000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pic>
          <p:nvPicPr>
            <p:cNvPr id="117" name="그림 71" descr="Nor m172 OK.jpg"/>
            <p:cNvPicPr/>
            <p:nvPr/>
          </p:nvPicPr>
          <p:blipFill>
            <a:blip r:embed="rId3"/>
            <a:srcRect l="12904" t="14464" r="8168" b="13216"/>
            <a:stretch/>
          </p:blipFill>
          <p:spPr>
            <a:xfrm>
              <a:off x="2179800" y="2005200"/>
              <a:ext cx="4680000" cy="3571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</p:grpSp>
      <p:pic>
        <p:nvPicPr>
          <p:cNvPr id="118" name="그림 73" descr="Nor m172 con Ok"/>
          <p:cNvPicPr/>
          <p:nvPr/>
        </p:nvPicPr>
        <p:blipFill>
          <a:blip r:embed="rId4"/>
          <a:srcRect l="7515" t="0" r="6289" b="20544"/>
          <a:stretch/>
        </p:blipFill>
        <p:spPr>
          <a:xfrm>
            <a:off x="2179800" y="2414520"/>
            <a:ext cx="4679640" cy="2858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19" name="그림 74" descr="NR m172OK.jpg"/>
          <p:cNvPicPr/>
          <p:nvPr/>
        </p:nvPicPr>
        <p:blipFill>
          <a:blip r:embed="rId5"/>
          <a:srcRect l="8834" t="15104" r="4974" b="15533"/>
          <a:stretch/>
        </p:blipFill>
        <p:spPr>
          <a:xfrm>
            <a:off x="2179800" y="2968560"/>
            <a:ext cx="4679640" cy="3510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20" name="그림 75" descr="NR m172con Ok.jpg"/>
          <p:cNvPicPr/>
          <p:nvPr/>
        </p:nvPicPr>
        <p:blipFill>
          <a:blip r:embed="rId6"/>
          <a:srcRect l="6729" t="0" r="0" b="0"/>
          <a:stretch/>
        </p:blipFill>
        <p:spPr>
          <a:xfrm>
            <a:off x="2179800" y="3373560"/>
            <a:ext cx="4663800" cy="2840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21" name="TextBox 78"/>
          <p:cNvSpPr/>
          <p:nvPr/>
        </p:nvSpPr>
        <p:spPr>
          <a:xfrm>
            <a:off x="934920" y="1071720"/>
            <a:ext cx="147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miR 172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2" name="TextBox 79"/>
          <p:cNvSpPr/>
          <p:nvPr/>
        </p:nvSpPr>
        <p:spPr>
          <a:xfrm>
            <a:off x="934920" y="2049480"/>
            <a:ext cx="147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miR 172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3" name="TextBox 80"/>
          <p:cNvSpPr/>
          <p:nvPr/>
        </p:nvSpPr>
        <p:spPr>
          <a:xfrm>
            <a:off x="934920" y="3000240"/>
            <a:ext cx="147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miR 172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4" name="TextBox 78"/>
          <p:cNvSpPr/>
          <p:nvPr/>
        </p:nvSpPr>
        <p:spPr>
          <a:xfrm>
            <a:off x="922320" y="1325520"/>
            <a:ext cx="147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5SRNA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5" name="TextBox 78"/>
          <p:cNvSpPr/>
          <p:nvPr/>
        </p:nvSpPr>
        <p:spPr>
          <a:xfrm>
            <a:off x="923760" y="2363760"/>
            <a:ext cx="147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5SRNA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6" name="TextBox 78"/>
          <p:cNvSpPr/>
          <p:nvPr/>
        </p:nvSpPr>
        <p:spPr>
          <a:xfrm>
            <a:off x="942840" y="3375000"/>
            <a:ext cx="147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5SRNA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127" name="그룹 52"/>
          <p:cNvGrpSpPr/>
          <p:nvPr/>
        </p:nvGrpSpPr>
        <p:grpSpPr>
          <a:xfrm>
            <a:off x="915840" y="3786120"/>
            <a:ext cx="5994720" cy="1371600"/>
            <a:chOff x="915840" y="3786120"/>
            <a:chExt cx="5994720" cy="1371600"/>
          </a:xfrm>
        </p:grpSpPr>
        <p:grpSp>
          <p:nvGrpSpPr>
            <p:cNvPr id="128" name="그룹 45"/>
            <p:cNvGrpSpPr/>
            <p:nvPr/>
          </p:nvGrpSpPr>
          <p:grpSpPr>
            <a:xfrm>
              <a:off x="915840" y="4043160"/>
              <a:ext cx="5994720" cy="1114560"/>
              <a:chOff x="915840" y="4043160"/>
              <a:chExt cx="5994720" cy="1114560"/>
            </a:xfrm>
          </p:grpSpPr>
          <p:grpSp>
            <p:nvGrpSpPr>
              <p:cNvPr id="129" name="그룹 59"/>
              <p:cNvGrpSpPr/>
              <p:nvPr/>
            </p:nvGrpSpPr>
            <p:grpSpPr>
              <a:xfrm>
                <a:off x="2538360" y="4043160"/>
                <a:ext cx="4372200" cy="276480"/>
                <a:chOff x="2538360" y="4043160"/>
                <a:chExt cx="4372200" cy="276480"/>
              </a:xfrm>
            </p:grpSpPr>
            <p:sp>
              <p:nvSpPr>
                <p:cNvPr id="130" name="Text Box 18"/>
                <p:cNvSpPr/>
                <p:nvPr/>
              </p:nvSpPr>
              <p:spPr>
                <a:xfrm>
                  <a:off x="2680920" y="4043160"/>
                  <a:ext cx="1871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굴림"/>
                    </a:rPr>
                    <a:t>WT</a:t>
                  </a:r>
                  <a:endParaRPr b="0" lang="en-US" sz="12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1" name="직선 연결선 10"/>
                <p:cNvSpPr/>
                <p:nvPr/>
              </p:nvSpPr>
              <p:spPr>
                <a:xfrm>
                  <a:off x="4662720" y="4274280"/>
                  <a:ext cx="194796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2" name="Text Box 20"/>
                <p:cNvSpPr/>
                <p:nvPr/>
              </p:nvSpPr>
              <p:spPr>
                <a:xfrm>
                  <a:off x="5038920" y="4043160"/>
                  <a:ext cx="1871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굴림"/>
                      <a:ea typeface="굴림"/>
                    </a:rPr>
                    <a:t>Cnr</a:t>
                  </a:r>
                  <a:endParaRPr b="0" lang="en-US" sz="12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3" name="직선 연결선 68"/>
                <p:cNvSpPr/>
                <p:nvPr/>
              </p:nvSpPr>
              <p:spPr>
                <a:xfrm>
                  <a:off x="2538360" y="4275000"/>
                  <a:ext cx="200016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</p:grpSp>
          <p:sp>
            <p:nvSpPr>
              <p:cNvPr id="134" name="TextBox 81"/>
              <p:cNvSpPr/>
              <p:nvPr/>
            </p:nvSpPr>
            <p:spPr>
              <a:xfrm>
                <a:off x="915840" y="4371840"/>
                <a:ext cx="1479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miR 172</a:t>
                </a:r>
                <a:endParaRPr b="0" lang="en-US" sz="1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5" name="TextBox 78"/>
              <p:cNvSpPr/>
              <p:nvPr/>
            </p:nvSpPr>
            <p:spPr>
              <a:xfrm>
                <a:off x="956520" y="4805280"/>
                <a:ext cx="1479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5SRNA</a:t>
                </a:r>
                <a:endParaRPr b="0" lang="en-US" sz="1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pic>
            <p:nvPicPr>
              <p:cNvPr id="136" name="Picture 50" descr="AC&amp;Cnr3-1OK"/>
              <p:cNvPicPr/>
              <p:nvPr/>
            </p:nvPicPr>
            <p:blipFill>
              <a:blip r:embed="rId7"/>
              <a:srcRect l="0" t="8456" r="0" b="18642"/>
              <a:stretch/>
            </p:blipFill>
            <p:spPr>
              <a:xfrm>
                <a:off x="2135160" y="4314600"/>
                <a:ext cx="4756680" cy="40968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137" name="Picture 51" descr="AC&amp;Cnr3 conOK"/>
              <p:cNvPicPr/>
              <p:nvPr/>
            </p:nvPicPr>
            <p:blipFill>
              <a:blip r:embed="rId8"/>
              <a:srcRect l="0" t="12946" r="0" b="12946"/>
              <a:stretch/>
            </p:blipFill>
            <p:spPr>
              <a:xfrm>
                <a:off x="2135160" y="4776840"/>
                <a:ext cx="4734360" cy="38088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</p:grpSp>
        <p:sp>
          <p:nvSpPr>
            <p:cNvPr id="138" name="TextBox 29"/>
            <p:cNvSpPr/>
            <p:nvPr/>
          </p:nvSpPr>
          <p:spPr>
            <a:xfrm>
              <a:off x="2500200" y="3786120"/>
              <a:ext cx="2252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F       D8      D20     D30    D35  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9" name="TextBox 29"/>
            <p:cNvSpPr/>
            <p:nvPr/>
          </p:nvSpPr>
          <p:spPr>
            <a:xfrm>
              <a:off x="4557960" y="3795480"/>
              <a:ext cx="2252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F       D8      D20     D30    D35  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0" name="직선 연결선 64"/>
            <p:cNvSpPr/>
            <p:nvPr/>
          </p:nvSpPr>
          <p:spPr>
            <a:xfrm>
              <a:off x="2485800" y="4066920"/>
              <a:ext cx="4153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직사각형 8"/>
          <p:cNvSpPr/>
          <p:nvPr/>
        </p:nvSpPr>
        <p:spPr>
          <a:xfrm>
            <a:off x="108000" y="4641840"/>
            <a:ext cx="8750160" cy="169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 S4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cumulation of miR172 in wild-type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r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nt fruit.  Tomato tissues (F, flower; D10, 10 days after 1 cm fruit; D20, 20 days after 1 cm fruit; D30, 30 days after 1 cm fruit; D35, 35 days after 1 cm fruit) were extracted for total RNA of which 20 μg/sample was separated for RNA gel-blot analysis using a 5′-end-labeled DNA oligonucleotide complementary to miR172 as probe. Tomato 5S rRNA was used as a loading control. RNA gel-blot analysis was repeated three times and relative expression was determined relative to transcript levels in flower.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142" name="Group 5"/>
          <p:cNvGrpSpPr/>
          <p:nvPr/>
        </p:nvGrpSpPr>
        <p:grpSpPr>
          <a:xfrm>
            <a:off x="1403280" y="404640"/>
            <a:ext cx="6769080" cy="4181760"/>
            <a:chOff x="1403280" y="404640"/>
            <a:chExt cx="6769080" cy="4181760"/>
          </a:xfrm>
        </p:grpSpPr>
        <p:pic>
          <p:nvPicPr>
            <p:cNvPr id="143" name="Chart 10" descr=""/>
            <p:cNvPicPr/>
            <p:nvPr/>
          </p:nvPicPr>
          <p:blipFill>
            <a:blip r:embed="rId1"/>
            <a:stretch/>
          </p:blipFill>
          <p:spPr>
            <a:xfrm>
              <a:off x="1403280" y="404640"/>
              <a:ext cx="6769080" cy="4181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4" name="TextBox 4"/>
            <p:cNvSpPr/>
            <p:nvPr/>
          </p:nvSpPr>
          <p:spPr>
            <a:xfrm>
              <a:off x="7018560" y="503640"/>
              <a:ext cx="575640" cy="381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182880" tIns="9144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Cnr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12T22:04:14Z</dcterms:created>
  <dc:creator>정미영</dc:creator>
  <dc:description/>
  <dc:language>en-US</dc:language>
  <cp:lastModifiedBy>UKN</cp:lastModifiedBy>
  <dcterms:modified xsi:type="dcterms:W3CDTF">2020-05-26T14:57:01Z</dcterms:modified>
  <cp:revision>553</cp:revision>
  <dc:subject/>
  <dc:title>슬라이드 1</dc:title>
</cp:coreProperties>
</file>